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83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5271C98-87FC-878C-0F00-9B77B9C719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38331619-AA73-1B2C-4F91-50B91EF424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BD16F7AD-4F21-2382-0D54-F4F28475E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242067C-DA34-416C-53DF-40D6573EC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60A3776-CA50-F760-6831-9733AC9D3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08905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A8C553B-C0A4-3A2B-E697-8A860F89E6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4319549B-F52B-C069-2004-A1A2D96EC5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EADB0E8-49F5-E9DB-4142-00F64B04D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4F092381-02E1-F1C7-B17A-E3156A00E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29A9184C-EFA1-E78D-0E14-B3C5A5BA1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43023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44687C7C-F63A-30A0-BAE0-BE2621C9E3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9D39A6A7-E585-2008-E648-F065D80338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5CCD1A61-24B1-9F28-28EB-EFB973873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FFB0FF3-5FDA-58C3-455B-3C38238E5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3F23979-C714-9479-078E-18C0215A5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18215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B70300C-ECF0-9599-7406-3F9EF2755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294D17A5-D6B9-022A-14A6-F2E9EBDF2D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601BDDDF-E7D7-A72C-966C-1392FE2D5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3D609E0E-8ED2-7A73-B380-319331604E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5AC2472B-0579-A67A-41CE-BD2606EB1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10978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14C4ED17-7C60-4DE8-7387-E2F48A3D0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472259B8-A551-329D-13C6-FBEDBB6CB5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3D2F3447-E4DC-52E2-3771-0C428A271F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2C585167-A2FC-FFB1-25AD-38EC8DC24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BD062503-5861-FB0E-F1CA-630A9A7EA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18197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B0BFDD92-3CD5-9429-80F0-E3188C8B4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F1ADFB87-BF35-FEB5-BA9D-A8463250B1F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606A8BD7-3088-597B-B503-D7792F1AFA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D15F5C98-1431-C584-D211-68DE07682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A815B337-6C97-07D5-A38E-DD4C84A5B8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52074354-4F86-C663-2152-09E0FD6D3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882668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EB0AD05-495D-0BFE-3FBF-8F76117AD4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F1D5B4FB-ED9B-62A1-AD85-CA1893B830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E979C772-5233-8E00-F452-B45CCC09E9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CF85B0B5-FBDE-46F7-D888-E069E54F1B9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E61A81BF-9A4C-A460-EFA8-79DD1A5D76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84B906C7-88CC-EF86-A49F-D8B6E0EC4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49F4EE28-8732-83D0-2492-60723F339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A240B192-94FE-051A-38FC-BFA03F0C69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502708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EF26924-6F3B-8C6A-E5B5-82D55ACC15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E50079D3-9BFF-E445-40FB-6ECCAB21D8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045BE892-2855-46FE-E96E-5088C2FF2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86C63E33-7A9C-5E5F-885E-53FD42352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35844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C3D193B5-BB62-66D3-9455-9ED6EA3BC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FD285403-8295-E6F9-642A-8040A4171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9FF3BF08-0C45-A7AF-7836-1706C4815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128917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60464D56-0696-704E-201E-C099695140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45D7FDC-349D-0986-039C-46BAC4D853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7BB4AA23-18AD-998C-E76B-BB5C88C441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EB40F39F-A105-5AAE-6C71-B06A44C6A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CA2D1429-6F1E-F260-25EC-67217BA33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F2E039F1-3958-3A77-1757-440D800087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0263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DAAF7DC-2D86-31C4-77DD-11A5B4F308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4ED3F2D1-5D80-5A5D-EC72-A3DAB7E14C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B3E1ACF4-0776-0173-24F9-58472D155E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EB23189-5A68-D923-0EFF-8C6E7053A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01E07C62-E498-41F9-1588-68FE4C69B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844EEAE8-3F54-B89D-F8D8-989756C50A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021633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9E70EF38-6FBE-0C99-DAA5-4334581CA4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E7D54374-0C81-016D-CCD3-425DD1037C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EFC0908-0AF1-88F3-B9A3-7976D88761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B1420-AA33-4363-8D94-A5616E7022B7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8189845-5C34-7398-5E6F-7EE9BDE9D0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A6CF941-EA39-D5E4-5006-A82B64A482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DC527E1-57D5-4373-8415-89F84308F2A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4586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>
            <a:extLst>
              <a:ext uri="{FF2B5EF4-FFF2-40B4-BE49-F238E27FC236}">
                <a16:creationId xmlns:a16="http://schemas.microsoft.com/office/drawing/2014/main" id="{E7854E1F-C6F3-72F8-01C6-F5564ED993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75608" y="715414"/>
            <a:ext cx="6903109" cy="3327105"/>
          </a:xfrm>
          <a:prstGeom prst="rect">
            <a:avLst/>
          </a:prstGeom>
        </p:spPr>
      </p:pic>
      <p:sp>
        <p:nvSpPr>
          <p:cNvPr id="5" name="Szövegdoboz 4">
            <a:extLst>
              <a:ext uri="{FF2B5EF4-FFF2-40B4-BE49-F238E27FC236}">
                <a16:creationId xmlns:a16="http://schemas.microsoft.com/office/drawing/2014/main" id="{3D2238A8-D09B-8237-CED1-CA18F462E694}"/>
              </a:ext>
            </a:extLst>
          </p:cNvPr>
          <p:cNvSpPr txBox="1"/>
          <p:nvPr/>
        </p:nvSpPr>
        <p:spPr>
          <a:xfrm>
            <a:off x="298515" y="4735234"/>
            <a:ext cx="11594969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hu-HU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lang="en-US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cium transients elicited by action potentials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epresentative calcium transient in response to a 0.3-ms supramaximal electrical stimulus. FDB fibers were loaded with the calcium-sensitive dye Fluo-8 AM. (B) Amplitude of calcium transients recorded in control (black) and Dooku1-pretreated (red) fibers. The mean ± SEM, calculated from 28 transients in both groups, is shown (number of mice=3).</a:t>
            </a:r>
            <a:endParaRPr lang="hu-HU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376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Office PowerPoint</Application>
  <PresentationFormat>Szélesvásznú</PresentationFormat>
  <Paragraphs>1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x Dienes</dc:creator>
  <cp:lastModifiedBy>Beatrix Dienes</cp:lastModifiedBy>
  <cp:revision>4</cp:revision>
  <dcterms:created xsi:type="dcterms:W3CDTF">2026-02-01T17:23:52Z</dcterms:created>
  <dcterms:modified xsi:type="dcterms:W3CDTF">2026-06-19T13:59:37Z</dcterms:modified>
</cp:coreProperties>
</file>